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8"/>
    <p:restoredTop sz="95304"/>
  </p:normalViewPr>
  <p:slideViewPr>
    <p:cSldViewPr snapToGrid="0" snapToObjects="1">
      <p:cViewPr varScale="1">
        <p:scale>
          <a:sx n="99" d="100"/>
          <a:sy n="99" d="100"/>
        </p:scale>
        <p:origin x="48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6EE51AA-DF52-AF41-A159-F05CE048FEB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2E952299-BAAD-DD48-8F4D-BA71BE74A47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B1B3604E-B185-EA47-89D2-DF96EDEC85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488246-53A0-D947-9279-BAA3B7EDF6C5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41EBB70F-8770-8D48-95C8-A684D5A038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F74114A1-51F7-3444-AF7F-D9CBAFDD29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B24592-46E6-B541-89C1-84F7CC0F6DDA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1554625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8815610-5F09-2C44-8AB9-631C1A26B9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FD116EE9-9E0F-F847-96CB-E8840F3185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AA2723C4-444A-7A4D-9D39-B031056B65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488246-53A0-D947-9279-BAA3B7EDF6C5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4E8084F6-2123-924F-A97B-E17B88125C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2EFF7C79-C9E4-8D43-970B-400CF2883B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B24592-46E6-B541-89C1-84F7CC0F6DDA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145326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39004BE4-61FF-B14C-9A26-512D159B5C5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544613BC-B9D7-E644-920E-15A43089C91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DF357262-8B48-2C4F-9BA9-FB23470003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488246-53A0-D947-9279-BAA3B7EDF6C5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9CCF7CC2-D61B-1144-A37F-48DA3AE886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E4C97A5A-1ABE-4A4F-BA6C-02D275E0A8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B24592-46E6-B541-89C1-84F7CC0F6DDA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2929827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6F38085-459F-BE40-8394-247F1D5FA6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620817E5-94E8-E74A-B1C0-E05B7D26732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214DEF96-13BC-2B49-94D0-14DFEEAC5D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488246-53A0-D947-9279-BAA3B7EDF6C5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A120CEA8-223A-DF4B-BE12-5DBD16165C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A15E8C81-C0D5-2049-9E6D-E6D0D96077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B24592-46E6-B541-89C1-84F7CC0F6DDA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7471843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1D21EB3-F014-354C-B2B1-F6099647C4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A66F839E-7102-554D-BAE8-56912BBCEB7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FB70E91E-61CB-7949-A6CE-FE8F613124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488246-53A0-D947-9279-BAA3B7EDF6C5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954EECF5-9FA2-F542-9818-16B0DC5FC8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69D1677B-7B39-F94A-8652-6FBA22E8AF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B24592-46E6-B541-89C1-84F7CC0F6DDA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2442284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FE393FA-5BD2-8C43-B608-E262E5D090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1A5D7066-B64F-F343-997B-D28193DC9F0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FB33A33F-8FBE-0744-8D23-0832B5B2EA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A429AEAD-46A6-EC47-A693-DFA0E16EE3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488246-53A0-D947-9279-BAA3B7EDF6C5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1B047FE7-056D-2747-A72A-B54A7E9211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0A62E03E-BFB0-6F4A-969A-DBC8F2C870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B24592-46E6-B541-89C1-84F7CC0F6DDA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261352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C28E0A3-AD17-EF48-A7F8-6091FEA397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CDB856C6-54F5-FF48-90ED-F1158ECC80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6D5880D2-EBF0-694B-A72D-52B3765FD40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>
            <a:extLst>
              <a:ext uri="{FF2B5EF4-FFF2-40B4-BE49-F238E27FC236}">
                <a16:creationId xmlns:a16="http://schemas.microsoft.com/office/drawing/2014/main" id="{87947DBE-0153-474F-A9B9-9C67437741F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Espaço Reservado para Conteúdo 5">
            <a:extLst>
              <a:ext uri="{FF2B5EF4-FFF2-40B4-BE49-F238E27FC236}">
                <a16:creationId xmlns:a16="http://schemas.microsoft.com/office/drawing/2014/main" id="{5CD2E515-F0C0-C244-A935-4CA5F7156E8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>
            <a:extLst>
              <a:ext uri="{FF2B5EF4-FFF2-40B4-BE49-F238E27FC236}">
                <a16:creationId xmlns:a16="http://schemas.microsoft.com/office/drawing/2014/main" id="{9B8C537C-4B80-4448-A60D-52F7F8A0BB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488246-53A0-D947-9279-BAA3B7EDF6C5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8" name="Espaço Reservado para Rodapé 7">
            <a:extLst>
              <a:ext uri="{FF2B5EF4-FFF2-40B4-BE49-F238E27FC236}">
                <a16:creationId xmlns:a16="http://schemas.microsoft.com/office/drawing/2014/main" id="{23B0D92F-5599-214C-BCE8-CACFCD0675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>
            <a:extLst>
              <a:ext uri="{FF2B5EF4-FFF2-40B4-BE49-F238E27FC236}">
                <a16:creationId xmlns:a16="http://schemas.microsoft.com/office/drawing/2014/main" id="{0FCF7B12-E08E-0C43-9926-CD9196E5BE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B24592-46E6-B541-89C1-84F7CC0F6DDA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2626475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26970C4-DE37-EE49-B9E6-CD00E38841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>
            <a:extLst>
              <a:ext uri="{FF2B5EF4-FFF2-40B4-BE49-F238E27FC236}">
                <a16:creationId xmlns:a16="http://schemas.microsoft.com/office/drawing/2014/main" id="{F161D163-A5B2-FD46-9821-8A99FA8837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488246-53A0-D947-9279-BAA3B7EDF6C5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4" name="Espaço Reservado para Rodapé 3">
            <a:extLst>
              <a:ext uri="{FF2B5EF4-FFF2-40B4-BE49-F238E27FC236}">
                <a16:creationId xmlns:a16="http://schemas.microsoft.com/office/drawing/2014/main" id="{D85EC326-5257-8A4A-BF6C-EEB68B6F39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>
            <a:extLst>
              <a:ext uri="{FF2B5EF4-FFF2-40B4-BE49-F238E27FC236}">
                <a16:creationId xmlns:a16="http://schemas.microsoft.com/office/drawing/2014/main" id="{C5855C16-6DDA-254C-A570-23BAFA83D2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B24592-46E6-B541-89C1-84F7CC0F6DDA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3137721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>
            <a:extLst>
              <a:ext uri="{FF2B5EF4-FFF2-40B4-BE49-F238E27FC236}">
                <a16:creationId xmlns:a16="http://schemas.microsoft.com/office/drawing/2014/main" id="{258AE6D2-BC55-E84D-94AD-1E8855FF73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488246-53A0-D947-9279-BAA3B7EDF6C5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3" name="Espaço Reservado para Rodapé 2">
            <a:extLst>
              <a:ext uri="{FF2B5EF4-FFF2-40B4-BE49-F238E27FC236}">
                <a16:creationId xmlns:a16="http://schemas.microsoft.com/office/drawing/2014/main" id="{86F198A5-AAC6-6E49-AE54-4F30CE8E97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>
            <a:extLst>
              <a:ext uri="{FF2B5EF4-FFF2-40B4-BE49-F238E27FC236}">
                <a16:creationId xmlns:a16="http://schemas.microsoft.com/office/drawing/2014/main" id="{825AC6C4-A10A-0A45-AD23-BBACE8135C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B24592-46E6-B541-89C1-84F7CC0F6DDA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6884316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A4EA1BB-F667-A34C-A64D-7F85B5328F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EDFBBD3E-AD5F-2341-968F-3ECADFEE08F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49E23955-8508-5E4F-A8DD-17B9EB5E1C6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9C77C5A5-D9BF-4A4A-8B80-419DAECBF7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488246-53A0-D947-9279-BAA3B7EDF6C5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2FC6F903-2264-CB44-AD94-1C4F14C4E2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8F6CF8A5-16A0-1440-B117-4280294C2B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B24592-46E6-B541-89C1-84F7CC0F6DDA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3023603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DEB4F56-B356-5948-BF5E-3CDE5C3188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>
            <a:extLst>
              <a:ext uri="{FF2B5EF4-FFF2-40B4-BE49-F238E27FC236}">
                <a16:creationId xmlns:a16="http://schemas.microsoft.com/office/drawing/2014/main" id="{8B735DAB-A37D-C648-B84C-91FE058A65E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F41A188F-28A1-CD4D-ACEE-DA33F7741E1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6BF118B6-049D-E840-B7A5-584C503520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488246-53A0-D947-9279-BAA3B7EDF6C5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AEC6E952-A515-0C41-B947-9978C18E31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41D9D3A6-44B4-644C-AC08-72BF35F625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B24592-46E6-B541-89C1-84F7CC0F6DDA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519978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>
            <a:extLst>
              <a:ext uri="{FF2B5EF4-FFF2-40B4-BE49-F238E27FC236}">
                <a16:creationId xmlns:a16="http://schemas.microsoft.com/office/drawing/2014/main" id="{4D43365F-A912-1542-AD36-2F9B49178D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DC7B251A-DABA-DB4C-A89F-424A877050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C6C7A350-636E-D24A-9A38-95F1F68FA5B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488246-53A0-D947-9279-BAA3B7EDF6C5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D38BDD20-9C5A-454F-A6B5-95148B18B48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EE919776-B319-B84E-B9B9-97297076272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B24592-46E6-B541-89C1-84F7CC0F6DDA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7006550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8" descr="Chart, box and whisker chart&#10;&#10;Description automatically generated">
            <a:extLst>
              <a:ext uri="{FF2B5EF4-FFF2-40B4-BE49-F238E27FC236}">
                <a16:creationId xmlns:a16="http://schemas.microsoft.com/office/drawing/2014/main" id="{6C0A28F6-179F-6B45-BBF4-D343A865AEE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06923" y="3014923"/>
            <a:ext cx="8205850" cy="2917635"/>
          </a:xfrm>
          <a:prstGeom prst="rect">
            <a:avLst/>
          </a:prstGeom>
        </p:spPr>
      </p:pic>
      <p:pic>
        <p:nvPicPr>
          <p:cNvPr id="5" name="Picture 4" descr="Chart, box and whisker chart&#10;&#10;Description automatically generated">
            <a:extLst>
              <a:ext uri="{FF2B5EF4-FFF2-40B4-BE49-F238E27FC236}">
                <a16:creationId xmlns:a16="http://schemas.microsoft.com/office/drawing/2014/main" id="{7120750B-2175-8547-8A19-84946FD4CEA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06923" y="345110"/>
            <a:ext cx="8205850" cy="2917635"/>
          </a:xfrm>
          <a:prstGeom prst="rect">
            <a:avLst/>
          </a:prstGeom>
        </p:spPr>
      </p:pic>
      <p:sp>
        <p:nvSpPr>
          <p:cNvPr id="6" name="TextBox 26">
            <a:extLst>
              <a:ext uri="{FF2B5EF4-FFF2-40B4-BE49-F238E27FC236}">
                <a16:creationId xmlns:a16="http://schemas.microsoft.com/office/drawing/2014/main" id="{A436FD6C-ADB9-F543-9166-8AF12C6033F2}"/>
              </a:ext>
            </a:extLst>
          </p:cNvPr>
          <p:cNvSpPr txBox="1"/>
          <p:nvPr/>
        </p:nvSpPr>
        <p:spPr>
          <a:xfrm>
            <a:off x="906923" y="5747892"/>
            <a:ext cx="1263534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9: Resistance index (RI) - mean difference between mild and severe pre-eclampsia </a:t>
            </a:r>
          </a:p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control groups</a:t>
            </a:r>
          </a:p>
        </p:txBody>
      </p:sp>
    </p:spTree>
    <p:extLst>
      <p:ext uri="{BB962C8B-B14F-4D97-AF65-F5344CB8AC3E}">
        <p14:creationId xmlns:p14="http://schemas.microsoft.com/office/powerpoint/2010/main" val="191921741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</Words>
  <Application>Microsoft Macintosh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o Office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Microsoft Office User</dc:creator>
  <cp:lastModifiedBy>Microsoft Office User</cp:lastModifiedBy>
  <cp:revision>1</cp:revision>
  <dcterms:created xsi:type="dcterms:W3CDTF">2022-02-06T21:26:57Z</dcterms:created>
  <dcterms:modified xsi:type="dcterms:W3CDTF">2022-02-06T21:27:20Z</dcterms:modified>
</cp:coreProperties>
</file>